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1986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084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423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0064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5165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9515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854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917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299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263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866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163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26F63-0BA8-4830-9E80-676206CD9C50}" type="datetimeFigureOut">
              <a:rPr kumimoji="1" lang="ja-JP" altLang="en-US" smtClean="0"/>
              <a:t>2019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6AE53-AEC3-4DF3-A5B1-D3DC0F1BD2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9553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2576830"/>
              </p:ext>
            </p:extLst>
          </p:nvPr>
        </p:nvGraphicFramePr>
        <p:xfrm>
          <a:off x="590768" y="705710"/>
          <a:ext cx="5548775" cy="781922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62112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3504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4202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8506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6552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5048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e inoculated with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</a:t>
                      </a:r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-</a:t>
                      </a:r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oculation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 no.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is (mg)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didymis (mg)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0656">
                <a:tc rowSpan="12">
                  <a:txBody>
                    <a:bodyPr/>
                    <a:lstStyle/>
                    <a:p>
                      <a:pPr algn="l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VABC59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weeks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weeks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0656">
                <a:tc rowSpan="12">
                  <a:txBody>
                    <a:bodyPr/>
                    <a:lstStyle/>
                    <a:p>
                      <a:pPr algn="l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IKV/Hu/S36/Chiba/2016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weeks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weeks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0656">
                <a:tc rowSpan="12">
                  <a:txBody>
                    <a:bodyPr/>
                    <a:lstStyle/>
                    <a:p>
                      <a:pPr algn="l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IKV/Hu/NIID123/201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weeks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lang="en-US" alt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weeks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</a:t>
                      </a:r>
                      <a:endParaRPr 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60656">
                <a:tc rowSpan="11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VABC59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months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</a:t>
                      </a:r>
                      <a:r>
                        <a:rPr lang="en-US" altLang="ja-JP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d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measured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60656">
                <a:tc vMerge="1">
                  <a:txBody>
                    <a:bodyPr/>
                    <a:lstStyle/>
                    <a:p>
                      <a:pPr algn="l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37" marR="8637" marT="8637" marB="0" anchor="ctr"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518984" y="444843"/>
            <a:ext cx="5251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Table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ght of testes and epididymides in mice inoculated with ZIKV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320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05</Words>
  <Application>Microsoft Office PowerPoint</Application>
  <PresentationFormat>画面に合わせる (4:3)</PresentationFormat>
  <Paragraphs>15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tajima</dc:creator>
  <cp:lastModifiedBy>田島 茂</cp:lastModifiedBy>
  <cp:revision>7</cp:revision>
  <dcterms:created xsi:type="dcterms:W3CDTF">2018-12-15T07:50:46Z</dcterms:created>
  <dcterms:modified xsi:type="dcterms:W3CDTF">2019-04-17T02:45:30Z</dcterms:modified>
</cp:coreProperties>
</file>